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7"/>
    <p:restoredTop sz="94686"/>
  </p:normalViewPr>
  <p:slideViewPr>
    <p:cSldViewPr snapToGrid="0" snapToObjects="1">
      <p:cViewPr>
        <p:scale>
          <a:sx n="87" d="100"/>
          <a:sy n="87" d="100"/>
        </p:scale>
        <p:origin x="-1482" y="-5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_tradnl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51880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42584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0229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67595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432563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51376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01694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3976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91035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59198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Marcador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253109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192C-8137-9B41-8187-96988804D1F2}" type="datetimeFigureOut">
              <a:rPr lang="es-ES_tradnl" smtClean="0"/>
              <a:t>02/02/2019</a:t>
            </a:fld>
            <a:endParaRPr lang="es-ES_tradn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A464C-0A97-784F-BCC3-425B6F70EEFB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415819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001356"/>
              </p:ext>
            </p:extLst>
          </p:nvPr>
        </p:nvGraphicFramePr>
        <p:xfrm>
          <a:off x="3081482" y="615243"/>
          <a:ext cx="5918200" cy="3474720"/>
        </p:xfrm>
        <a:graphic>
          <a:graphicData uri="http://schemas.openxmlformats.org/drawingml/2006/table">
            <a:tbl>
              <a:tblPr firstRow="1" firstCol="1" bandRow="1"/>
              <a:tblGrid>
                <a:gridCol w="109664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852295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15900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81026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b="1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Gene</a:t>
                      </a:r>
                      <a:endParaRPr lang="es-ES_tradnl" sz="12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b="1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Variable</a:t>
                      </a:r>
                      <a:endParaRPr lang="es-ES_tradnl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b="1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Means (SD)</a:t>
                      </a:r>
                      <a:endParaRPr lang="es-ES_tradnl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b="1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P value</a:t>
                      </a:r>
                      <a:endParaRPr lang="es-ES_tradnl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i="1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FERD3L</a:t>
                      </a:r>
                      <a:endParaRPr lang="es-ES_tradnl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Age (&gt;=45 vs &lt;45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cT (&lt;2 vs &gt;=2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cN (N0 vs N+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ki67 (&lt;50% vs &gt;=50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30.1 (16.9) vs 21.7 (17.8)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18.9 (13.0) vs 27.6 (18.2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27.7 (18.2) vs 22.9 (15.8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24.5 (16.0) vs 26.3 (18.0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14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12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39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75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i="1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TRIP10</a:t>
                      </a:r>
                      <a:endParaRPr lang="es-ES_tradnl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Age (&gt;=45 vs &lt;45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cT (&lt;2 vs &gt;=2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cN (N0 vs N+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ki67 (&lt;50% vs &gt;=50%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28.7 (17.4) vs 27.2 (15.3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31.8 (23.0) vs 27.7 (13.9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26.7 (12.2) vs 31.1 (22.5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30.1 (13.9) vs 26.0 (18.4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75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97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49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0.44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ES_tradnl" sz="1200" dirty="0">
                          <a:effectLst/>
                          <a:latin typeface="Cambria" charset="0"/>
                          <a:ea typeface="ＭＳ 明朝" charset="-128"/>
                          <a:cs typeface="Times New Roman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2" name="Rectángulo 11"/>
          <p:cNvSpPr/>
          <p:nvPr/>
        </p:nvSpPr>
        <p:spPr>
          <a:xfrm>
            <a:off x="3081482" y="4531457"/>
            <a:ext cx="59182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s-ES_tradnl" sz="1100" b="1" dirty="0" err="1" smtClean="0">
                <a:effectLst/>
                <a:latin typeface="Calibri" charset="0"/>
                <a:ea typeface="ＭＳ 明朝" charset="-128"/>
                <a:cs typeface="Times New Roman" charset="0"/>
              </a:rPr>
              <a:t>Table</a:t>
            </a:r>
            <a:r>
              <a:rPr lang="es-ES_tradnl" sz="1100" b="1" smtClean="0">
                <a:effectLst/>
                <a:latin typeface="Calibri" charset="0"/>
                <a:ea typeface="ＭＳ 明朝" charset="-128"/>
                <a:cs typeface="Times New Roman" charset="0"/>
              </a:rPr>
              <a:t> S5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. Mean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differences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in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methylation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levels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according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to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clinicopathological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prognostic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factors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in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both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cohorts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(DC+VC).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cT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: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Clinical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tumor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size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;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cN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: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Clinical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nodule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 </a:t>
            </a:r>
            <a:r>
              <a:rPr lang="es-ES_tradnl" sz="1100" dirty="0" err="1">
                <a:effectLst/>
                <a:latin typeface="Calibri" charset="0"/>
                <a:ea typeface="ＭＳ 明朝" charset="-128"/>
                <a:cs typeface="Times New Roman" charset="0"/>
              </a:rPr>
              <a:t>affectation</a:t>
            </a:r>
            <a:r>
              <a:rPr lang="es-ES_tradnl" sz="1100" dirty="0">
                <a:effectLst/>
                <a:latin typeface="Calibri" charset="0"/>
                <a:ea typeface="ＭＳ 明朝" charset="-128"/>
                <a:cs typeface="Times New Roman" charset="0"/>
              </a:rPr>
              <a:t>.</a:t>
            </a:r>
            <a:endParaRPr lang="es-ES_tradnl" sz="1100" dirty="0">
              <a:effectLst/>
              <a:latin typeface="Cambria" charset="0"/>
              <a:ea typeface="ＭＳ 明朝" charset="-128"/>
              <a:cs typeface="Times New Roman" charset="0"/>
            </a:endParaRPr>
          </a:p>
          <a:p>
            <a:pPr>
              <a:spcAft>
                <a:spcPts val="0"/>
              </a:spcAft>
            </a:pPr>
            <a:r>
              <a:rPr lang="es-ES_tradnl" sz="1100" dirty="0">
                <a:effectLst/>
                <a:latin typeface="Cambria" charset="0"/>
                <a:ea typeface="ＭＳ 明朝" charset="-128"/>
                <a:cs typeface="Times New Roman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8438640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9</Words>
  <Application>Microsoft Office PowerPoint</Application>
  <PresentationFormat>Custom</PresentationFormat>
  <Paragraphs>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 de Microsoft Office</dc:creator>
  <cp:lastModifiedBy>JABELLA</cp:lastModifiedBy>
  <cp:revision>4</cp:revision>
  <dcterms:created xsi:type="dcterms:W3CDTF">2019-01-11T11:22:58Z</dcterms:created>
  <dcterms:modified xsi:type="dcterms:W3CDTF">2019-02-01T22:50:35Z</dcterms:modified>
</cp:coreProperties>
</file>